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735763" cy="987107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4FBFBB-778A-469A-B30D-FF5F5716B24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26B223-3A11-496E-BFDD-6DAE740FBC0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00E5CE-DB8E-49D7-B98D-661FB50451C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63FF9A-88C2-40C4-9DF9-6DA196F81C4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007B9D-9EED-44E8-9026-6D08601E489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996049-DE87-458D-BF71-E3ED91FFFDF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F133D4-4A2B-4685-8AE1-5C71EE3E401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F6EB18-9480-4F48-A487-21F2036DD52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578518-7740-49B9-9956-6921F770EB9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095156-B7E1-477C-8ADE-0CC78E0D86F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58EEED-0718-471A-9BBC-8B65B0F3F61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19D661-7397-4E6B-9A9E-4735DA2D516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굴림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굴림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굴림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굴림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굴림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굴림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4B0D79B-3217-43B4-9028-DC3D8F6ABF64}" type="slidenum">
              <a:rPr b="0" lang="en-US" sz="1400" spc="-1" strike="noStrike">
                <a:solidFill>
                  <a:srgbClr val="000000"/>
                </a:solidFill>
                <a:latin typeface="굴림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4"/>
          <p:cNvSpPr/>
          <p:nvPr/>
        </p:nvSpPr>
        <p:spPr>
          <a:xfrm>
            <a:off x="826920" y="981000"/>
            <a:ext cx="76536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Table S7. Histone family members are listed with their mRNA levels in response to heat shock and MG132 treatment. Fold changes more than 2 are colored in red and less than -2 are colored in green. 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2" name="Text Box 5"/>
          <p:cNvSpPr/>
          <p:nvPr/>
        </p:nvSpPr>
        <p:spPr>
          <a:xfrm>
            <a:off x="124920" y="31680"/>
            <a:ext cx="2504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굴림"/>
              </a:rPr>
              <a:t>Supplemental Table 7</a:t>
            </a: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3" name=""/>
          <p:cNvGraphicFramePr/>
          <p:nvPr/>
        </p:nvGraphicFramePr>
        <p:xfrm>
          <a:off x="755640" y="360360"/>
          <a:ext cx="7704000" cy="6396120"/>
        </p:xfrm>
        <a:graphic>
          <a:graphicData uri="http://schemas.openxmlformats.org/drawingml/2006/table">
            <a:tbl>
              <a:tblPr/>
              <a:tblGrid>
                <a:gridCol w="1224000"/>
                <a:gridCol w="647640"/>
                <a:gridCol w="238320"/>
                <a:gridCol w="309240"/>
                <a:gridCol w="308160"/>
                <a:gridCol w="309600"/>
                <a:gridCol w="307800"/>
                <a:gridCol w="309600"/>
                <a:gridCol w="308160"/>
                <a:gridCol w="309600"/>
                <a:gridCol w="307800"/>
                <a:gridCol w="308160"/>
                <a:gridCol w="309240"/>
                <a:gridCol w="309600"/>
                <a:gridCol w="308160"/>
                <a:gridCol w="307800"/>
                <a:gridCol w="308160"/>
                <a:gridCol w="309600"/>
                <a:gridCol w="388800"/>
                <a:gridCol w="574560"/>
              </a:tblGrid>
              <a:tr h="249480"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Gene Nam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Symbol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RH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RH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RH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RH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TH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TH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TH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TH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RM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RM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RM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RM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TM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TM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TM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TM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T/R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Accession No.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27800"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Histone cluster 1, H1b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Hist1h1b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1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1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1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1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NM_020034.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0980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Histone cluster 1, H1c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Hist1h1c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3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008000"/>
                          </a:solidFill>
                          <a:latin typeface="Arial"/>
                          <a:ea typeface="돋움"/>
                        </a:rPr>
                        <a:t>-2.0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008000"/>
                          </a:solidFill>
                          <a:latin typeface="Arial"/>
                          <a:ea typeface="돋움"/>
                        </a:rPr>
                        <a:t>-3.2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7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2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4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9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008000"/>
                          </a:solidFill>
                          <a:latin typeface="Arial"/>
                          <a:ea typeface="돋움"/>
                        </a:rPr>
                        <a:t>-4.4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4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1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2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1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9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NM_015786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980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Histone cluster 1, H1d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Hist1h1d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1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1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1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1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1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1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2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NM_145713.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0980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Histone cluster 1, H2ab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Hist1h2ab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2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3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2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4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1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2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7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2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3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8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NM_175660.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0980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Histone cluster 1, H2ae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Hist1h2ae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ff0000"/>
                          </a:solidFill>
                          <a:latin typeface="Arial"/>
                          <a:ea typeface="돋움"/>
                        </a:rPr>
                        <a:t>3.6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7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6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3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6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8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2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3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2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NM_178187.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980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Histone cluster 1, H2af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Hist1h2af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008000"/>
                          </a:solidFill>
                          <a:latin typeface="Arial"/>
                          <a:ea typeface="돋움"/>
                        </a:rPr>
                        <a:t>-2.9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008000"/>
                          </a:solidFill>
                          <a:latin typeface="Arial"/>
                          <a:ea typeface="돋움"/>
                        </a:rPr>
                        <a:t>-4.4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5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008000"/>
                          </a:solidFill>
                          <a:latin typeface="Arial"/>
                          <a:ea typeface="돋움"/>
                        </a:rPr>
                        <a:t>-2.4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1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008000"/>
                          </a:solidFill>
                          <a:latin typeface="Arial"/>
                          <a:ea typeface="돋움"/>
                        </a:rPr>
                        <a:t>-2.9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008000"/>
                          </a:solidFill>
                          <a:latin typeface="Arial"/>
                          <a:ea typeface="돋움"/>
                        </a:rPr>
                        <a:t>-2.2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008000"/>
                          </a:solidFill>
                          <a:latin typeface="Arial"/>
                          <a:ea typeface="돋움"/>
                        </a:rPr>
                        <a:t>-5.0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3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008000"/>
                          </a:solidFill>
                          <a:latin typeface="Arial"/>
                          <a:ea typeface="돋움"/>
                        </a:rPr>
                        <a:t>-2.9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008000"/>
                          </a:solidFill>
                          <a:latin typeface="Arial"/>
                          <a:ea typeface="돋움"/>
                        </a:rPr>
                        <a:t>-3.9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1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NM_175661.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980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Histone cluster 1, H2ah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Hist1h2ah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008000"/>
                          </a:solidFill>
                          <a:latin typeface="Arial"/>
                          <a:ea typeface="돋움"/>
                        </a:rPr>
                        <a:t>-3.0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008000"/>
                          </a:solidFill>
                          <a:latin typeface="Arial"/>
                          <a:ea typeface="돋움"/>
                        </a:rPr>
                        <a:t>-4.8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008000"/>
                          </a:solidFill>
                          <a:latin typeface="Arial"/>
                          <a:ea typeface="돋움"/>
                        </a:rPr>
                        <a:t>-2.7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1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008000"/>
                          </a:solidFill>
                          <a:latin typeface="Arial"/>
                          <a:ea typeface="돋움"/>
                        </a:rPr>
                        <a:t>-3.5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008000"/>
                          </a:solidFill>
                          <a:latin typeface="Arial"/>
                          <a:ea typeface="돋움"/>
                        </a:rPr>
                        <a:t>-2.8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008000"/>
                          </a:solidFill>
                          <a:latin typeface="Arial"/>
                          <a:ea typeface="돋움"/>
                        </a:rPr>
                        <a:t>-6.7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2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008000"/>
                          </a:solidFill>
                          <a:latin typeface="Arial"/>
                          <a:ea typeface="돋움"/>
                        </a:rPr>
                        <a:t>-3.1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008000"/>
                          </a:solidFill>
                          <a:latin typeface="Arial"/>
                          <a:ea typeface="돋움"/>
                        </a:rPr>
                        <a:t>-4.4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1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NM_175659.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980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Histone cluster 1, H2ai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Hist1h2ai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9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008000"/>
                          </a:solidFill>
                          <a:latin typeface="Arial"/>
                          <a:ea typeface="돋움"/>
                        </a:rPr>
                        <a:t>-2.8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2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008000"/>
                          </a:solidFill>
                          <a:latin typeface="Arial"/>
                          <a:ea typeface="돋움"/>
                        </a:rPr>
                        <a:t>-2.7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008000"/>
                          </a:solidFill>
                          <a:latin typeface="Arial"/>
                          <a:ea typeface="돋움"/>
                        </a:rPr>
                        <a:t>-2.1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008000"/>
                          </a:solidFill>
                          <a:latin typeface="Arial"/>
                          <a:ea typeface="돋움"/>
                        </a:rPr>
                        <a:t>-4.5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2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008000"/>
                          </a:solidFill>
                          <a:latin typeface="Arial"/>
                          <a:ea typeface="돋움"/>
                        </a:rPr>
                        <a:t>-2.6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008000"/>
                          </a:solidFill>
                          <a:latin typeface="Arial"/>
                          <a:ea typeface="돋움"/>
                        </a:rPr>
                        <a:t>-3.3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NM_17818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980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Histone cluster 1, H2an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Hist1h2an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008000"/>
                          </a:solidFill>
                          <a:latin typeface="Arial"/>
                          <a:ea typeface="돋움"/>
                        </a:rPr>
                        <a:t>-3.2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008000"/>
                          </a:solidFill>
                          <a:latin typeface="Arial"/>
                          <a:ea typeface="돋움"/>
                        </a:rPr>
                        <a:t>-5.2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4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008000"/>
                          </a:solidFill>
                          <a:latin typeface="Arial"/>
                          <a:ea typeface="돋움"/>
                        </a:rPr>
                        <a:t>-2.6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1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008000"/>
                          </a:solidFill>
                          <a:latin typeface="Arial"/>
                          <a:ea typeface="돋움"/>
                        </a:rPr>
                        <a:t>-2.7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008000"/>
                          </a:solidFill>
                          <a:latin typeface="Arial"/>
                          <a:ea typeface="돋움"/>
                        </a:rPr>
                        <a:t>-2.2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008000"/>
                          </a:solidFill>
                          <a:latin typeface="Arial"/>
                          <a:ea typeface="돋움"/>
                        </a:rPr>
                        <a:t>-4.9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3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008000"/>
                          </a:solidFill>
                          <a:latin typeface="Arial"/>
                          <a:ea typeface="돋움"/>
                        </a:rPr>
                        <a:t>-2.7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008000"/>
                          </a:solidFill>
                          <a:latin typeface="Arial"/>
                          <a:ea typeface="돋움"/>
                        </a:rPr>
                        <a:t>-3.3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1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NM_178184.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980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Histone cluster 1, H2ao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Hist1h2ao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008000"/>
                          </a:solidFill>
                          <a:latin typeface="Arial"/>
                          <a:ea typeface="돋움"/>
                        </a:rPr>
                        <a:t>-2.2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008000"/>
                          </a:solidFill>
                          <a:latin typeface="Arial"/>
                          <a:ea typeface="돋움"/>
                        </a:rPr>
                        <a:t>-3.2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008000"/>
                          </a:solidFill>
                          <a:latin typeface="Arial"/>
                          <a:ea typeface="돋움"/>
                        </a:rPr>
                        <a:t>-2.0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008000"/>
                          </a:solidFill>
                          <a:latin typeface="Arial"/>
                          <a:ea typeface="돋움"/>
                        </a:rPr>
                        <a:t>-2.8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008000"/>
                          </a:solidFill>
                          <a:latin typeface="Arial"/>
                          <a:ea typeface="돋움"/>
                        </a:rPr>
                        <a:t>-2.1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008000"/>
                          </a:solidFill>
                          <a:latin typeface="Arial"/>
                          <a:ea typeface="돋움"/>
                        </a:rPr>
                        <a:t>-4.7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2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008000"/>
                          </a:solidFill>
                          <a:latin typeface="Arial"/>
                          <a:ea typeface="돋움"/>
                        </a:rPr>
                        <a:t>-2.7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008000"/>
                          </a:solidFill>
                          <a:latin typeface="Arial"/>
                          <a:ea typeface="돋움"/>
                        </a:rPr>
                        <a:t>-3.4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NM_178185.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0980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Histone cluster 1, H2ba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Hist1h2ba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0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0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1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0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NM_175663.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0980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Histone cluster 1, H2bc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Hist1h2bc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0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7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1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2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6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0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8000"/>
                          </a:solidFill>
                          <a:latin typeface="돋움"/>
                          <a:ea typeface="돋움"/>
                        </a:rPr>
                        <a:t>-2.5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8000"/>
                          </a:solidFill>
                          <a:latin typeface="돋움"/>
                          <a:ea typeface="돋움"/>
                        </a:rPr>
                        <a:t>-4.4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3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4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2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2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5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NM_02342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980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Histone cluster 1, H2bf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Hist1h2bf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6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1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5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7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3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5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8000"/>
                          </a:solidFill>
                          <a:latin typeface="돋움"/>
                          <a:ea typeface="돋움"/>
                        </a:rPr>
                        <a:t>-2.3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9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2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4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3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1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NM_178195.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980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Histone cluster 1, H2bg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Hist1h2bg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1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0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0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0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0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0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0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1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NM_178196.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980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Histone cluster 1, H2bh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Hist1h2bh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2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6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1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6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6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3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3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8000"/>
                          </a:solidFill>
                          <a:latin typeface="돋움"/>
                          <a:ea typeface="돋움"/>
                        </a:rPr>
                        <a:t>-2.1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9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2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4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3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1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NM_178197.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980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Histone cluster 1, H2bj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Hist1h2bj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7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0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6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7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2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5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8000"/>
                          </a:solidFill>
                          <a:latin typeface="돋움"/>
                          <a:ea typeface="돋움"/>
                        </a:rPr>
                        <a:t>-2.5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8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2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4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2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NM_178198.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980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Histone cluster 1, H2bk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Hist1h2bk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2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5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4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3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1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3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8000"/>
                          </a:solidFill>
                          <a:latin typeface="돋움"/>
                          <a:ea typeface="돋움"/>
                        </a:rPr>
                        <a:t>-2.0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8000"/>
                          </a:solidFill>
                          <a:latin typeface="돋움"/>
                          <a:ea typeface="돋움"/>
                        </a:rPr>
                        <a:t>-2.2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3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7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8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2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NM_175665.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980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Histone cluster 1, H2bl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Hist1h2bl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6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1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4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7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2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4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8000"/>
                          </a:solidFill>
                          <a:latin typeface="돋움"/>
                          <a:ea typeface="돋움"/>
                        </a:rPr>
                        <a:t>-2.1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7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1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2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2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1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NM_178199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980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Histone cluster 1, H2bm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Hist1h2bm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1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6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5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7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2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4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8000"/>
                          </a:solidFill>
                          <a:latin typeface="돋움"/>
                          <a:ea typeface="돋움"/>
                        </a:rPr>
                        <a:t>-2.5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8000"/>
                          </a:solidFill>
                          <a:latin typeface="돋움"/>
                          <a:ea typeface="돋움"/>
                        </a:rPr>
                        <a:t>-2.0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2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4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2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NM_178200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980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Histone cluster 1, H2bn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Hist1h2bn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1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6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1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5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5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1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4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8000"/>
                          </a:solidFill>
                          <a:latin typeface="돋움"/>
                          <a:ea typeface="돋움"/>
                        </a:rPr>
                        <a:t>-2.2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8000"/>
                          </a:solidFill>
                          <a:latin typeface="돋움"/>
                          <a:ea typeface="돋움"/>
                        </a:rPr>
                        <a:t>-2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2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4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3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1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NM_178201.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980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Histone cluster 1, H2bp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Hist1h2bp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1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5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4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5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1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5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8000"/>
                          </a:solidFill>
                          <a:latin typeface="돋움"/>
                          <a:ea typeface="돋움"/>
                        </a:rPr>
                        <a:t>-2.4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8000"/>
                          </a:solidFill>
                          <a:latin typeface="돋움"/>
                          <a:ea typeface="돋움"/>
                        </a:rPr>
                        <a:t>-2.2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3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6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3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2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NM_17820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0980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Histone cluster 1, H3b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Hist1h3b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3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5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4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1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1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9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8000"/>
                          </a:solidFill>
                          <a:latin typeface="돋움"/>
                          <a:ea typeface="돋움"/>
                        </a:rPr>
                        <a:t>-4.1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1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7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8000"/>
                          </a:solidFill>
                          <a:latin typeface="돋움"/>
                          <a:ea typeface="돋움"/>
                        </a:rPr>
                        <a:t>-2.8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NM_178203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0980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Histone cluster 1, H3c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Hist1h3c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1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1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1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2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0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1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3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9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4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9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NM_175653.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980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Histone cluster 1, H3d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Hist1h3d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3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5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4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1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7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8000"/>
                          </a:solidFill>
                          <a:latin typeface="돋움"/>
                          <a:ea typeface="돋움"/>
                        </a:rPr>
                        <a:t>-3.5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1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6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8000"/>
                          </a:solidFill>
                          <a:latin typeface="돋움"/>
                          <a:ea typeface="돋움"/>
                        </a:rPr>
                        <a:t>-2.8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NM_178204.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980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Histone cluster 1, H3e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Hist1h3e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3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5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4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1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2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9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8000"/>
                          </a:solidFill>
                          <a:latin typeface="돋움"/>
                          <a:ea typeface="돋움"/>
                        </a:rPr>
                        <a:t>-4.1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1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6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8000"/>
                          </a:solidFill>
                          <a:latin typeface="돋움"/>
                          <a:ea typeface="돋움"/>
                        </a:rPr>
                        <a:t>-2.8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NM_178205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980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Histone cluster 1, H3h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Hist1h3h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3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4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1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2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0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0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6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8000"/>
                          </a:solidFill>
                          <a:latin typeface="돋움"/>
                          <a:ea typeface="돋움"/>
                        </a:rPr>
                        <a:t>-2.1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2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7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1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NM_178206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980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Histone cluster 1, H3i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Hist1h3i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4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8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1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5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1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1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8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8000"/>
                          </a:solidFill>
                          <a:latin typeface="돋움"/>
                          <a:ea typeface="돋움"/>
                        </a:rPr>
                        <a:t>-3.4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1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6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8000"/>
                          </a:solidFill>
                          <a:latin typeface="돋움"/>
                          <a:ea typeface="돋움"/>
                        </a:rPr>
                        <a:t>-2.5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NM_178207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0980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Histone cluster 1, H4a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Hist1h4a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ff0000"/>
                          </a:solidFill>
                          <a:latin typeface="돋움"/>
                          <a:ea typeface="돋움"/>
                        </a:rPr>
                        <a:t>2.3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ff0000"/>
                          </a:solidFill>
                          <a:latin typeface="돋움"/>
                          <a:ea typeface="돋움"/>
                        </a:rPr>
                        <a:t>2.5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4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8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4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1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3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8000"/>
                          </a:solidFill>
                          <a:latin typeface="돋움"/>
                          <a:ea typeface="돋움"/>
                        </a:rPr>
                        <a:t>-2.1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8000"/>
                          </a:solidFill>
                          <a:latin typeface="돋움"/>
                          <a:ea typeface="돋움"/>
                        </a:rPr>
                        <a:t>-2.4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1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6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8000"/>
                          </a:solidFill>
                          <a:latin typeface="돋움"/>
                          <a:ea typeface="돋움"/>
                        </a:rPr>
                        <a:t>-2.1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2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NM_17819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0980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Histone cluster 1, H4b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Hist1h4b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5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4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4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0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5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6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2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2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1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NM_178193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980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Histone cluster 1, H4d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Hist1h4d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ff0000"/>
                          </a:solidFill>
                          <a:latin typeface="돋움"/>
                          <a:ea typeface="돋움"/>
                        </a:rPr>
                        <a:t>2.2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ff0000"/>
                          </a:solidFill>
                          <a:latin typeface="돋움"/>
                          <a:ea typeface="돋움"/>
                        </a:rPr>
                        <a:t>2.6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5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ff0000"/>
                          </a:solidFill>
                          <a:latin typeface="돋움"/>
                          <a:ea typeface="돋움"/>
                        </a:rPr>
                        <a:t>2.1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2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2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1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5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1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3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1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NM_175654.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980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Histone cluster 1, H4f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Hist1h4f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6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7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2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5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2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1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4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8000"/>
                          </a:solidFill>
                          <a:latin typeface="돋움"/>
                          <a:ea typeface="돋움"/>
                        </a:rPr>
                        <a:t>-2.2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8000"/>
                          </a:solidFill>
                          <a:latin typeface="돋움"/>
                          <a:ea typeface="돋움"/>
                        </a:rPr>
                        <a:t>-2.3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1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6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8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1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NM_175655.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980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Histone cluster 1, H4h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Hist1h4h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ff0000"/>
                          </a:solidFill>
                          <a:latin typeface="돋움"/>
                          <a:ea typeface="돋움"/>
                        </a:rPr>
                        <a:t>2.2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ff0000"/>
                          </a:solidFill>
                          <a:latin typeface="돋움"/>
                          <a:ea typeface="돋움"/>
                        </a:rPr>
                        <a:t>2.3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7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7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2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2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0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1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2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0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0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2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2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NM_153173.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980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Histone cluster 1, H4i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Hist1h4i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5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6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6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3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1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2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6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7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2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3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6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NM_175656.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980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Histone cluster 1, H4j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Hist1h4j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ff0000"/>
                          </a:solidFill>
                          <a:latin typeface="돋움"/>
                          <a:ea typeface="돋움"/>
                        </a:rPr>
                        <a:t>2.4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ff0000"/>
                          </a:solidFill>
                          <a:latin typeface="돋움"/>
                          <a:ea typeface="돋움"/>
                        </a:rPr>
                        <a:t>2.8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5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ff0000"/>
                          </a:solidFill>
                          <a:latin typeface="돋움"/>
                          <a:ea typeface="돋움"/>
                        </a:rPr>
                        <a:t>2.1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4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1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2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3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1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0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6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1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NM_178210.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980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Histone cluster 1, H4k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Hist1h4k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ff0000"/>
                          </a:solidFill>
                          <a:latin typeface="돋움"/>
                          <a:ea typeface="돋움"/>
                        </a:rPr>
                        <a:t>2.8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ff0000"/>
                          </a:solidFill>
                          <a:latin typeface="돋움"/>
                          <a:ea typeface="돋움"/>
                        </a:rPr>
                        <a:t>3.5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6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ff0000"/>
                          </a:solidFill>
                          <a:latin typeface="돋움"/>
                          <a:ea typeface="돋움"/>
                        </a:rPr>
                        <a:t>2.3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4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3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1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4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0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3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1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NM_178211.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980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Histone cluster 1, H4m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Hist1h4m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ff0000"/>
                          </a:solidFill>
                          <a:latin typeface="돋움"/>
                          <a:ea typeface="돋움"/>
                        </a:rPr>
                        <a:t>2.0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ff0000"/>
                          </a:solidFill>
                          <a:latin typeface="돋움"/>
                          <a:ea typeface="돋움"/>
                        </a:rPr>
                        <a:t>2.2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4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9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3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1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3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4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4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1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3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4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NM_175657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0980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Histone cluster 2, H2aa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Hist2h2aa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1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0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1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0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0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0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0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2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NM_013549.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0980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Histone cluster 2, H2aa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Hist2h2aa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3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8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5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2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3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1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1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2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2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0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0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0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4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NM_17821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980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Histone cluster 2, H2ac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Hist2h2ac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8000"/>
                          </a:solidFill>
                          <a:latin typeface="돋움"/>
                          <a:ea typeface="돋움"/>
                        </a:rPr>
                        <a:t>-2.2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8000"/>
                          </a:solidFill>
                          <a:latin typeface="돋움"/>
                          <a:ea typeface="돋움"/>
                        </a:rPr>
                        <a:t>-3.3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0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8000"/>
                          </a:solidFill>
                          <a:latin typeface="돋움"/>
                          <a:ea typeface="돋움"/>
                        </a:rPr>
                        <a:t>-2.1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0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0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8000"/>
                          </a:solidFill>
                          <a:latin typeface="돋움"/>
                          <a:ea typeface="돋움"/>
                        </a:rPr>
                        <a:t>-2.9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8000"/>
                          </a:solidFill>
                          <a:latin typeface="돋움"/>
                          <a:ea typeface="돋움"/>
                        </a:rPr>
                        <a:t>-2.3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8000"/>
                          </a:solidFill>
                          <a:latin typeface="돋움"/>
                          <a:ea typeface="돋움"/>
                        </a:rPr>
                        <a:t>-4.6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3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8000"/>
                          </a:solidFill>
                          <a:latin typeface="돋움"/>
                          <a:ea typeface="돋움"/>
                        </a:rPr>
                        <a:t>-3.1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8000"/>
                          </a:solidFill>
                          <a:latin typeface="돋움"/>
                          <a:ea typeface="돋움"/>
                        </a:rPr>
                        <a:t>-3.4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0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NM_17566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980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Histone cluster 3, H2ba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Hist3h2ba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1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1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0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1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0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1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0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0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0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NM_030082.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980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Histone cluster 2, H2be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Hist2h2be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4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9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1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7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1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1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0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6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8000"/>
                          </a:solidFill>
                          <a:latin typeface="돋움"/>
                          <a:ea typeface="돋움"/>
                        </a:rPr>
                        <a:t>-2.9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0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3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8000"/>
                          </a:solidFill>
                          <a:latin typeface="돋움"/>
                          <a:ea typeface="돋움"/>
                        </a:rPr>
                        <a:t>-2.2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0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NM_178214.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980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Histone cluster 2, H3b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Hist2h3b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4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7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1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4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4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8000"/>
                          </a:solidFill>
                          <a:latin typeface="돋움"/>
                          <a:ea typeface="돋움"/>
                        </a:rPr>
                        <a:t>-2.2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2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9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NM_178215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980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Histone cluster 2, H4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Hist2h4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1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2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1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0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1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1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2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2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0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2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2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NM_033596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980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Histone cluster 4, H4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Hist4h4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8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9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2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4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0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1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1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2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2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3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NM_175652.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980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Centromere protein A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Cenpa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1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4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5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2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4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2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8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6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9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6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4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8000"/>
                          </a:solidFill>
                          <a:latin typeface="돋움"/>
                          <a:ea typeface="돋움"/>
                        </a:rPr>
                        <a:t>-2.4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0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NM_007681.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980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H1 histone family, member X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H1fx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1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2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1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2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0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6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3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8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9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2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8000"/>
                          </a:solidFill>
                          <a:latin typeface="돋움"/>
                          <a:ea typeface="돋움"/>
                        </a:rPr>
                        <a:t>-2.2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8000"/>
                          </a:solidFill>
                          <a:latin typeface="돋움"/>
                          <a:ea typeface="돋움"/>
                        </a:rPr>
                        <a:t>-2.2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0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NM_198622.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980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H2A histone family, member J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H2afj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3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ff0000"/>
                          </a:solidFill>
                          <a:latin typeface="돋움"/>
                          <a:ea typeface="돋움"/>
                        </a:rPr>
                        <a:t>4.4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5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ff0000"/>
                          </a:solidFill>
                          <a:latin typeface="돋움"/>
                          <a:ea typeface="돋움"/>
                        </a:rPr>
                        <a:t>2.2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1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1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0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1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1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2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1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1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1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NM_177688.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980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H2A histone family, member X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H2afx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3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8000"/>
                          </a:solidFill>
                          <a:latin typeface="돋움"/>
                          <a:ea typeface="돋움"/>
                        </a:rPr>
                        <a:t>-2.8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8000"/>
                          </a:solidFill>
                          <a:latin typeface="돋움"/>
                          <a:ea typeface="돋움"/>
                        </a:rPr>
                        <a:t>-2.3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4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2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0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6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8000"/>
                          </a:solidFill>
                          <a:latin typeface="돋움"/>
                          <a:ea typeface="돋움"/>
                        </a:rPr>
                        <a:t>-3.2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8000"/>
                          </a:solidFill>
                          <a:latin typeface="돋움"/>
                          <a:ea typeface="돋움"/>
                        </a:rPr>
                        <a:t>-3.7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8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8000"/>
                          </a:solidFill>
                          <a:latin typeface="돋움"/>
                          <a:ea typeface="돋움"/>
                        </a:rPr>
                        <a:t>-2.4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8000"/>
                          </a:solidFill>
                          <a:latin typeface="돋움"/>
                          <a:ea typeface="돋움"/>
                        </a:rPr>
                        <a:t>-2.4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1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NM_010436.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980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H2A histone family, member Y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H2afy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2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1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0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2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0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1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0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1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0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NM_012015.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980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H2A histone family, member Z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H2afz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0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2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8000"/>
                          </a:solidFill>
                          <a:latin typeface="돋움"/>
                          <a:ea typeface="돋움"/>
                        </a:rPr>
                        <a:t>-5.3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0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6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0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1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5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6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2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2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5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NM_016750.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980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H3 histone, family 3A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H3f3a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2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5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1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6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0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3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9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3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0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5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4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2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NM_008210.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980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H3 histone, family 3B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H3f3b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2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1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8000"/>
                          </a:solidFill>
                          <a:latin typeface="돋움"/>
                          <a:ea typeface="돋움"/>
                        </a:rPr>
                        <a:t>-2.0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1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4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2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1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4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6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2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4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2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NM_008211.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980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Metastasis associated 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Mta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1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0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2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2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3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1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2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2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1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3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1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2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NM_054081.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980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Metastasis-associated 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Mta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1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1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1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3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1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0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2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0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1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NM_011842.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980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Metastasis associated 3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Mta3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2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1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3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2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5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1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1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1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0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1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7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NM_054082.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980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RIKEN cDNA 1700113O17 gene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700113O17Rik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1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0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3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1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0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1.0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0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0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-1.1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돋움"/>
                          <a:ea typeface="돋움"/>
                        </a:rPr>
                        <a:t>NM_026627.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4" name="Text Box 5356"/>
          <p:cNvSpPr/>
          <p:nvPr/>
        </p:nvSpPr>
        <p:spPr>
          <a:xfrm>
            <a:off x="104040" y="0"/>
            <a:ext cx="2504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굴림"/>
              </a:rPr>
              <a:t>Supplemental Table 7</a:t>
            </a: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552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1-03T02:49:26Z</dcterms:created>
  <dc:creator>김희정</dc:creator>
  <dc:description/>
  <dc:language>en-US</dc:language>
  <cp:lastModifiedBy>김희정</cp:lastModifiedBy>
  <dcterms:modified xsi:type="dcterms:W3CDTF">2011-06-14T01:53:26Z</dcterms:modified>
  <cp:revision>199</cp:revision>
  <dc:subject/>
  <dc:title>슬라이드 1</dc:title>
</cp:coreProperties>
</file>